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2CD9943-0976-384F-B47A-8FACDC6D8CBD}" v="1" dt="2019-04-10T10:11:17.533"/>
    <p1510:client id="{2E307807-7EF2-3F45-AC88-2207640D267B}" v="1" dt="2019-04-10T10:33:02.8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borah Lipski" userId="cd64e408eec4740c" providerId="LiveId" clId="{2E307807-7EF2-3F45-AC88-2207640D267B}"/>
    <pc:docChg chg="custSel addSld delSld modSld">
      <pc:chgData name="Deborah Lipski" userId="cd64e408eec4740c" providerId="LiveId" clId="{2E307807-7EF2-3F45-AC88-2207640D267B}" dt="2019-04-10T10:33:05.416" v="2" actId="478"/>
      <pc:docMkLst>
        <pc:docMk/>
      </pc:docMkLst>
      <pc:sldChg chg="del">
        <pc:chgData name="Deborah Lipski" userId="cd64e408eec4740c" providerId="LiveId" clId="{2E307807-7EF2-3F45-AC88-2207640D267B}" dt="2019-04-10T10:33:01.962" v="0" actId="2696"/>
        <pc:sldMkLst>
          <pc:docMk/>
          <pc:sldMk cId="132887893" sldId="263"/>
        </pc:sldMkLst>
      </pc:sldChg>
      <pc:sldChg chg="delSp add">
        <pc:chgData name="Deborah Lipski" userId="cd64e408eec4740c" providerId="LiveId" clId="{2E307807-7EF2-3F45-AC88-2207640D267B}" dt="2019-04-10T10:33:05.416" v="2" actId="478"/>
        <pc:sldMkLst>
          <pc:docMk/>
          <pc:sldMk cId="1906286250" sldId="294"/>
        </pc:sldMkLst>
        <pc:spChg chg="del">
          <ac:chgData name="Deborah Lipski" userId="cd64e408eec4740c" providerId="LiveId" clId="{2E307807-7EF2-3F45-AC88-2207640D267B}" dt="2019-04-10T10:33:05.416" v="2" actId="478"/>
          <ac:spMkLst>
            <pc:docMk/>
            <pc:sldMk cId="1906286250" sldId="294"/>
            <ac:spMk id="7" creationId="{00000000-0000-0000-0000-000000000000}"/>
          </ac:spMkLst>
        </pc:spChg>
      </pc:sldChg>
    </pc:docChg>
  </pc:docChgLst>
  <pc:docChgLst>
    <pc:chgData name="Deborah Lipski" userId="cd64e408eec4740c" providerId="LiveId" clId="{72CD9943-0976-384F-B47A-8FACDC6D8CBD}"/>
    <pc:docChg chg="custSel addSld delSld modSld">
      <pc:chgData name="Deborah Lipski" userId="cd64e408eec4740c" providerId="LiveId" clId="{72CD9943-0976-384F-B47A-8FACDC6D8CBD}" dt="2019-04-10T10:11:21.443" v="2" actId="478"/>
      <pc:docMkLst>
        <pc:docMk/>
      </pc:docMkLst>
      <pc:sldChg chg="del">
        <pc:chgData name="Deborah Lipski" userId="cd64e408eec4740c" providerId="LiveId" clId="{72CD9943-0976-384F-B47A-8FACDC6D8CBD}" dt="2019-04-10T10:11:18.595" v="1" actId="2696"/>
        <pc:sldMkLst>
          <pc:docMk/>
          <pc:sldMk cId="2324155290" sldId="256"/>
        </pc:sldMkLst>
      </pc:sldChg>
      <pc:sldChg chg="delSp add">
        <pc:chgData name="Deborah Lipski" userId="cd64e408eec4740c" providerId="LiveId" clId="{72CD9943-0976-384F-B47A-8FACDC6D8CBD}" dt="2019-04-10T10:11:21.443" v="2" actId="478"/>
        <pc:sldMkLst>
          <pc:docMk/>
          <pc:sldMk cId="132887893" sldId="263"/>
        </pc:sldMkLst>
        <pc:spChg chg="del">
          <ac:chgData name="Deborah Lipski" userId="cd64e408eec4740c" providerId="LiveId" clId="{72CD9943-0976-384F-B47A-8FACDC6D8CBD}" dt="2019-04-10T10:11:21.443" v="2" actId="478"/>
          <ac:spMkLst>
            <pc:docMk/>
            <pc:sldMk cId="132887893" sldId="263"/>
            <ac:spMk id="2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366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108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68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5008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041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35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29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62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263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416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577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/>
          <p:cNvGraphicFramePr>
            <a:graphicFrameLocks noGrp="1"/>
          </p:cNvGraphicFramePr>
          <p:nvPr>
            <p:extLst/>
          </p:nvPr>
        </p:nvGraphicFramePr>
        <p:xfrm>
          <a:off x="723306" y="776536"/>
          <a:ext cx="5441998" cy="7641626"/>
        </p:xfrm>
        <a:graphic>
          <a:graphicData uri="http://schemas.openxmlformats.org/drawingml/2006/table">
            <a:tbl>
              <a:tblPr/>
              <a:tblGrid>
                <a:gridCol w="18663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33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76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8010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6534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5954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36377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43954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78538">
                <a:tc>
                  <a:txBody>
                    <a:bodyPr/>
                    <a:lstStyle/>
                    <a:p>
                      <a:pPr algn="l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ene ID 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ogFC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DR 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BE"/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ene ID </a:t>
                      </a:r>
                    </a:p>
                    <a:p>
                      <a:pPr algn="ctr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ogFC</a:t>
                      </a:r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DR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3510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2m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lpha-2-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acroglobul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,276045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,00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Ubap1l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Ubiquit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Associated Protein 1 Like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4063755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,15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38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rpina3n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rpin Family A Member 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,1687859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27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pp2r2b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rotein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Phosphat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2 Regulatory Subunit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Bbet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37296414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69872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328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gf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Fibroblast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growth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factor 2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,587485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41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lu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Cluster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lang="fr-BE" sz="600" b="0" i="0" u="none" strike="noStrike" dirty="0">
                        <a:solidFill>
                          <a:srgbClr val="333333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368003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9,92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dn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Endothelin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2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,5692274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,01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rmpd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FERM And PDZ Domain Containing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343741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00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2423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lp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electin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P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0778737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41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lc1a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Solute Carrier Family 1 Member 3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lang="en-US" sz="600" b="0" i="0" u="none" strike="noStrike" dirty="0">
                        <a:solidFill>
                          <a:srgbClr val="333333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3302123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31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0582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rss56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Proteas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serine 56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yps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-like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767487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55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f21b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Kines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Family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mber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21B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3172053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00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8741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le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electine E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6168363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69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nf207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Ring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Finger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Protein 2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31303238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37684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38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cn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ipocalin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508865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01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T8SIA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ST8 Alpha-N-</a:t>
                      </a:r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Acetyl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-</a:t>
                      </a:r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Neuraminide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Alpha-2,8-</a:t>
                      </a:r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Sialyltransferase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3,2637866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2,4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8515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g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eucine Rich Alpha-2-Glycoprotein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4631616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52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udt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Nudix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Hydrolase 6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lang="fr-BE" sz="600" b="0" i="0" u="none" strike="noStrike" dirty="0">
                        <a:solidFill>
                          <a:srgbClr val="333333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3,2636551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1,23528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ss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333333"/>
                          </a:solidFill>
                          <a:latin typeface="Times New Roman"/>
                        </a:rPr>
                        <a:t>Cathepsin S</a:t>
                      </a:r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lang="fr-BE" sz="600" b="0" i="0" u="none" strike="noStrike">
                        <a:solidFill>
                          <a:srgbClr val="333333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,1614504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38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qp4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Aquapor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4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2494673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17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sf2rb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olony Stimulating Factor 2 Receptor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94087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44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lk5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olo Like Kinase 5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2300039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37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06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4b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omplément 4b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,714009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9,52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Vat1l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Vesicle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Amine Transport 1 Like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1928612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61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mplément 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058859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77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tcl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icrotubule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rosslinking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Factor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1202684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52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48975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rrc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eucine Rich Repeat Containing 2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931943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09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upr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Nuclear Protein 1, Transcriptional Regulator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0873089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17E-0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imp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Tissue Inhibitor Of Metalloproteinases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8265331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31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Upp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Uridin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Phosphorylase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039888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,0001072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87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ckr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Atypical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Chemokine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Receptor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3302373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50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irpa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Signal </a:t>
                      </a:r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Regulatory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Protein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Alpha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9822872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38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690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ad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adinin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266059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35E-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lim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pha-Actinin-2-Associated LIM Protein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97896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,0024766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619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yc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V-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yc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Avia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yelocytomatosis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Viral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Oncogen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Homolog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188255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59E-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actbl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actamas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Beta Like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8837807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78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D44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Hematopoietic Cell E- And L-Select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lang="en-US" sz="600" b="0" i="0" u="none" strike="noStrike" dirty="0">
                        <a:solidFill>
                          <a:srgbClr val="333333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1343724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,76E-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damts4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DAM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tallopeptid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With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hrombospond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Type 1 Motif 4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559462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14E-0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6512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t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tallothione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0857081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72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dlim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arboxyl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Terminal LIM Domain Protein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138707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,0027328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4671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Dc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Decor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016488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40E-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 rowSpan="2" gridSpan="5">
                  <a:txBody>
                    <a:bodyPr/>
                    <a:lstStyle/>
                    <a:p>
                      <a:pPr algn="ctr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pPr algn="ctr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l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l" fontAlgn="t"/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f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ansferrin</a:t>
                      </a:r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9992227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,54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 gridSpan="5"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B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tp8b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ATPase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Phospholipid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ansporting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8B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9655062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53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Mx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MX dynamin like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GTP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0670108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4,66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9801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t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tallothione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8566028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73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Cd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Cluster of Differentiation 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0816887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6,93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619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md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onocyte To Macrophage Differentiation Associated 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8376263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44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Arhgap27os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Rho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GTP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activating protein 27, opposite strand 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09555166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9,99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938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lf1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lfatase 1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81132134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31427E-11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2610307P16Rik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RIKEN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cDNA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2610307P16 gene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17657150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7,21E-0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619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ctp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ultiple C2 And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ansmembran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Domain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ontaining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806656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07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Tcf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transcription factor 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18593238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0,0017929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938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il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hitinase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like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746033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36E-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6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Fam181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family with sequence similarity 181 member 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2497186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1,06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9711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Pdp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Podoplan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7186796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,13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Ism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isthmin 1, angiogenesis inhibito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2886920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5,08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66831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D14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yeloid Cell-Specific Leucine-Rich Glycoprotein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710177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95E-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Alox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arachidonat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12-lipoxygenase, 12S ty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3392472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8,25E-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8619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lc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galencephalic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eukoencephalopathy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With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ubcortical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ysts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672791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81E-0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Ifi2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interferon activated gene 2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3547388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0,000161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8619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lc14a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olute Carrier Family 14 (Urea Transporter), Member 1 (Kidd Blood Group)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665083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5,00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Akr1c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aldo-keto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reduct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family 1, member C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3588142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0,000299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Lpcat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Lysophosphatidylcholine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Acyltransferase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 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63739019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,48E-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Ifi2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 err="1">
                          <a:solidFill>
                            <a:schemeClr val="tx1"/>
                          </a:solidFill>
                          <a:latin typeface="Cambria"/>
                        </a:rPr>
                        <a:t>Interferon</a:t>
                      </a:r>
                      <a:r>
                        <a:rPr lang="fr-BE" sz="600" b="0" i="0" u="none" strike="noStrike" baseline="0" dirty="0">
                          <a:solidFill>
                            <a:schemeClr val="tx1"/>
                          </a:solidFill>
                          <a:latin typeface="Cambria"/>
                        </a:rPr>
                        <a:t> </a:t>
                      </a:r>
                      <a:r>
                        <a:rPr lang="fr-BE" sz="600" b="0" i="0" u="none" strike="noStrike" baseline="0" dirty="0" err="1">
                          <a:solidFill>
                            <a:schemeClr val="tx1"/>
                          </a:solidFill>
                          <a:latin typeface="Cambria"/>
                        </a:rPr>
                        <a:t>activited</a:t>
                      </a:r>
                      <a:r>
                        <a:rPr lang="fr-BE" sz="600" b="0" i="0" u="none" strike="noStrike" baseline="0" dirty="0">
                          <a:solidFill>
                            <a:schemeClr val="tx1"/>
                          </a:solidFill>
                          <a:latin typeface="Cambria"/>
                        </a:rPr>
                        <a:t> </a:t>
                      </a:r>
                      <a:r>
                        <a:rPr lang="fr-BE" sz="600" b="0" i="0" u="none" strike="noStrike" baseline="0" dirty="0" err="1">
                          <a:solidFill>
                            <a:schemeClr val="tx1"/>
                          </a:solidFill>
                          <a:latin typeface="Cambria"/>
                        </a:rPr>
                        <a:t>gene</a:t>
                      </a:r>
                      <a:r>
                        <a:rPr lang="fr-BE" sz="600" b="0" i="0" u="none" strike="noStrike" baseline="0" dirty="0">
                          <a:solidFill>
                            <a:schemeClr val="tx1"/>
                          </a:solidFill>
                          <a:latin typeface="Cambria"/>
                        </a:rPr>
                        <a:t> 208</a:t>
                      </a:r>
                      <a:endParaRPr lang="en-US" sz="600" b="0" i="0" u="none" strike="noStrike" dirty="0">
                        <a:solidFill>
                          <a:schemeClr val="tx1"/>
                        </a:solidFill>
                        <a:latin typeface="Cambria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39070818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1,36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77890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4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xyd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XYD Domain Containing Ion Transport Regulator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6350697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00E-0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Kank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KN motif and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ankyr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repeat domains 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4117580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1,78E-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9121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Itgb8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Integr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ubunit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Beta 8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630733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,86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Trim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tripartite motif containing 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4828178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5,79E-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cgb3a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ecretoglob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Family 3A Member 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61982667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42277E-0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Abcc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ATP-binding cassette, sub-family C member 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55385779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0,000511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7635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7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Il3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terleukine 33 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5445275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34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Edn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Endothelin-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mbria"/>
                        </a:rPr>
                        <a:t>-2,5883245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2,31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93849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pr37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Protein-Coupled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Receptor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37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5056425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72E-0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Vwa3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von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mbria"/>
                        </a:rPr>
                        <a:t>Willebrand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 factor A domain containing 3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6190066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5,07E-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43214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Dapl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Death Associated Protein Like 1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4805664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,0002964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Notu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Notum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6830248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3,59E-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0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is 1 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is Homeobox 1 </a:t>
                      </a:r>
                    </a:p>
                  </a:txBody>
                  <a:tcPr marL="1656" marR="1656" marT="152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45101861</a:t>
                      </a:r>
                    </a:p>
                  </a:txBody>
                  <a:tcPr marL="1656" marR="1656" marT="152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,08E-11</a:t>
                      </a:r>
                    </a:p>
                  </a:txBody>
                  <a:tcPr marL="1656" marR="1656" marT="152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LamC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Laminin, Gamma 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-2,72156918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mbria"/>
                        </a:rPr>
                        <a:t>8,21E-0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Igsf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Immunoglobul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uperfamily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mber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1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4291064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45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1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rss23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 err="1">
                          <a:solidFill>
                            <a:srgbClr val="333333"/>
                          </a:solidFill>
                          <a:latin typeface="Times New Roman"/>
                        </a:rPr>
                        <a:t>Protease</a:t>
                      </a:r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, Serine 23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-2,85196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333333"/>
                          </a:solidFill>
                          <a:latin typeface="Times New Roman"/>
                        </a:rPr>
                        <a:t>0,000000108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99648"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Zfyve28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Zinc Finger FYVE-Type Containing 28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,42601115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,45E-10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82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asq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Calsequestrin</a:t>
                      </a:r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2 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-3,3713206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fr-BE" sz="6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,00023559</a:t>
                      </a:r>
                    </a:p>
                  </a:txBody>
                  <a:tcPr marL="1656" marR="1656" marT="152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</a:tbl>
          </a:graphicData>
        </a:graphic>
      </p:graphicFrame>
      <p:sp>
        <p:nvSpPr>
          <p:cNvPr id="12" name="Flèche droite 11"/>
          <p:cNvSpPr/>
          <p:nvPr/>
        </p:nvSpPr>
        <p:spPr>
          <a:xfrm>
            <a:off x="514032" y="2229194"/>
            <a:ext cx="106656" cy="59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4" name="Flèche droite 13"/>
          <p:cNvSpPr/>
          <p:nvPr/>
        </p:nvSpPr>
        <p:spPr>
          <a:xfrm>
            <a:off x="514032" y="1293090"/>
            <a:ext cx="106656" cy="59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5" name="Flèche droite 14"/>
          <p:cNvSpPr/>
          <p:nvPr/>
        </p:nvSpPr>
        <p:spPr>
          <a:xfrm>
            <a:off x="510154" y="3480303"/>
            <a:ext cx="106656" cy="59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0" name="Flèche droite 19"/>
          <p:cNvSpPr>
            <a:spLocks noChangeAspect="1"/>
          </p:cNvSpPr>
          <p:nvPr/>
        </p:nvSpPr>
        <p:spPr>
          <a:xfrm rot="10800000">
            <a:off x="6227439" y="7935460"/>
            <a:ext cx="108000" cy="6026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" name="Flèche droite 9"/>
          <p:cNvSpPr/>
          <p:nvPr/>
        </p:nvSpPr>
        <p:spPr>
          <a:xfrm>
            <a:off x="514032" y="2421327"/>
            <a:ext cx="106656" cy="5951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9062862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96</Words>
  <Application>Microsoft Macintosh PowerPoint</Application>
  <PresentationFormat>Format A4 (210 x 297 mm)</PresentationFormat>
  <Paragraphs>4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borah Lipski</dc:creator>
  <cp:lastModifiedBy>Deborah Lipski</cp:lastModifiedBy>
  <cp:revision>1</cp:revision>
  <dcterms:created xsi:type="dcterms:W3CDTF">2019-04-10T10:03:16Z</dcterms:created>
  <dcterms:modified xsi:type="dcterms:W3CDTF">2019-04-10T10:33:06Z</dcterms:modified>
</cp:coreProperties>
</file>